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4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38" y="13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AD57C5-8C61-470F-9455-6D79F36C28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36F8F5D-7D69-4C70-90D7-1EA51268F3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2EF5D2-3731-4105-A52C-3A03263CE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EDFCE-1A55-44A8-B8DD-BB4464E27102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AF8CB3-5C7D-4B49-AD37-573A6BCB36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71B0BA-B971-4C8D-AD16-5EB49DC03C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AEE9A-9144-488A-9E72-20D370A8DF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4774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BB710E-B9CE-479E-9DEA-B6EB9600E4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8916F1-E919-4349-82F1-4F900ED345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63A60A-00ED-4413-9FCA-159408D0FF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EDFCE-1A55-44A8-B8DD-BB4464E27102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BFD074-8D18-41DD-865F-04CAE1F396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F268F6-A593-4BAF-8C52-2818B46040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AEE9A-9144-488A-9E72-20D370A8DF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807609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203FDDA-98F7-4879-AADC-B8B86896F2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C4B6FA-EEC5-4746-B827-C0EA8C73B6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9133CF-A72B-4483-B3D4-5C9153EFC5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EDFCE-1A55-44A8-B8DD-BB4464E27102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C8CB49-BA80-4C38-9348-37FA9EED12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010F29-38DE-467F-8643-C763714DA2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AEE9A-9144-488A-9E72-20D370A8DF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07073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AF2E5D-3247-432D-976C-48B7E7B105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17E744-5844-494F-8E7B-15C4444E8C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FA0116-C8BC-4EB3-AA5C-8FC744D8ED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EDFCE-1A55-44A8-B8DD-BB4464E27102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3799C3-1DD8-485B-90A8-BF0333D7CB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15FF2D-8198-47BB-B37E-CB713B6233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AEE9A-9144-488A-9E72-20D370A8DF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066562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A422DF-FB62-47C9-8BF3-2A8DA65545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90DB43-A003-4959-81A9-5501C30051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C532BC-0C0F-4083-910E-54EDFC98F6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EDFCE-1A55-44A8-B8DD-BB4464E27102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4EDA8F-385B-40ED-997F-A9D85FC028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4DD30B-0C1F-43F9-823F-189E9E388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AEE9A-9144-488A-9E72-20D370A8DF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459547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CA9384-1BD2-48F3-B6DD-3227DAE5B4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3C2C22-C77E-4126-8B53-C5458DDADFB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3FD089-B2AA-41AC-858D-9D7861434B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AD36DA-C704-4A44-944F-6ABF8F613E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EDFCE-1A55-44A8-B8DD-BB4464E27102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41D76A-F829-4A64-8E7E-FCF9E86E20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92EBC4C-122C-4810-B109-D38FC547E4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AEE9A-9144-488A-9E72-20D370A8DF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65685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631D6C-CA1E-4475-AC3C-55CD9B2395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5CA84E-EE38-4C3C-8090-EEF909511E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D0088D6-400A-444E-889D-0C4D4AA48F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F43A6DE-FFAF-4682-B2D9-BDD085F15A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A732CFB-A834-41DE-A022-3280D90EA3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0A4DF4-340B-41D3-8FDA-06088B670A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EDFCE-1A55-44A8-B8DD-BB4464E27102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6D19F16-0F49-47A8-BBF8-CE5EAE3A4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AAA3368-EE62-4FFF-83E8-9B8E6497F9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AEE9A-9144-488A-9E72-20D370A8DF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6655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0A4A47-913A-4444-9742-CDC253C61F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0CBFA6A-C350-405C-A193-94EC56889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EDFCE-1A55-44A8-B8DD-BB4464E27102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4F6B33-1DBE-429F-BBEE-231C766F1B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F028AD-9F11-4B5E-9A75-463B2D90B8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AEE9A-9144-488A-9E72-20D370A8DF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419639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77FF4E2-D681-4008-B042-A1D326A147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EDFCE-1A55-44A8-B8DD-BB4464E27102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D3FBB3F-2A57-407C-B16C-0D9D7145A9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B96A96B-2FF9-41DB-98A9-3C0839FBA0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AEE9A-9144-488A-9E72-20D370A8DF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64265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D172FD-3EF1-4027-936D-61C8F73A4D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3F0469-57A3-482C-A682-9BD400458A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16CA10-12B2-4DD8-93A2-90C04FE48D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882A63-57B5-44F4-8D38-FAC16C0E66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EDFCE-1A55-44A8-B8DD-BB4464E27102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826FC8-1AE3-4C71-A5C8-D4916FDBC6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4CF55C-24F5-4007-B28C-F8E381239B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AEE9A-9144-488A-9E72-20D370A8DF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42601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40C374-BC1F-4A85-B967-2107F42833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59482F1-3445-46B3-980F-9C699062A3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13E2E04-48B5-4876-B0CF-95FB9F8861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0DD539-3629-45AE-94A5-4E5809961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EDFCE-1A55-44A8-B8DD-BB4464E27102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E42407-C297-4F8A-AC5D-1AEA2E33AA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C627CD-6F5D-498D-9BDC-FACB474EA6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AEE9A-9144-488A-9E72-20D370A8DF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98933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F3F93DF-9F15-4EB0-B29B-7E5822FC52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DCAAD9-C48D-4BAA-9291-37DFB488EB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B14B9A-63C1-4BFF-BA33-6A73F924C77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5EDFCE-1A55-44A8-B8DD-BB4464E27102}" type="datetimeFigureOut">
              <a:rPr lang="en-AU" smtClean="0"/>
              <a:t>4/12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9D40AB-197B-41C3-8F73-91A6F9FB398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DC2F33-F7D0-479F-AC64-F9F82CD220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CAEE9A-9144-488A-9E72-20D370A8DF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89861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A close up of a computer&#10;&#10;Description automatically generated">
            <a:extLst>
              <a:ext uri="{FF2B5EF4-FFF2-40B4-BE49-F238E27FC236}">
                <a16:creationId xmlns:a16="http://schemas.microsoft.com/office/drawing/2014/main" id="{0D824CCC-4B16-406C-8CE0-45544E0548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1712" y="2466973"/>
            <a:ext cx="4326426" cy="4057650"/>
          </a:xfrm>
          <a:prstGeom prst="rect">
            <a:avLst/>
          </a:prstGeom>
        </p:spPr>
      </p:pic>
      <p:pic>
        <p:nvPicPr>
          <p:cNvPr id="15" name="Picture 14" descr="A picture containing computer&#10;&#10;Description automatically generated">
            <a:extLst>
              <a:ext uri="{FF2B5EF4-FFF2-40B4-BE49-F238E27FC236}">
                <a16:creationId xmlns:a16="http://schemas.microsoft.com/office/drawing/2014/main" id="{0102FC38-BDD1-444F-A9A9-FB17ADFAA09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2764" y="2466973"/>
            <a:ext cx="4326425" cy="4057649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690973D8-642A-4CB4-958E-C24C29DC55B0}"/>
              </a:ext>
            </a:extLst>
          </p:cNvPr>
          <p:cNvSpPr txBox="1"/>
          <p:nvPr/>
        </p:nvSpPr>
        <p:spPr>
          <a:xfrm>
            <a:off x="2552700" y="59293"/>
            <a:ext cx="1226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9EA107D-FA03-4430-9AA6-0BB222E6A8FC}"/>
              </a:ext>
            </a:extLst>
          </p:cNvPr>
          <p:cNvSpPr txBox="1"/>
          <p:nvPr/>
        </p:nvSpPr>
        <p:spPr>
          <a:xfrm>
            <a:off x="8117653" y="59293"/>
            <a:ext cx="1614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ified </a:t>
            </a:r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3C1AEBA-A8BD-4EB3-9FA6-124347EB2526}"/>
              </a:ext>
            </a:extLst>
          </p:cNvPr>
          <p:cNvSpPr txBox="1"/>
          <p:nvPr/>
        </p:nvSpPr>
        <p:spPr>
          <a:xfrm rot="18003512">
            <a:off x="1673153" y="1800082"/>
            <a:ext cx="10989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0428B67-F902-4BD9-84E9-D705E3F4262F}"/>
              </a:ext>
            </a:extLst>
          </p:cNvPr>
          <p:cNvSpPr txBox="1"/>
          <p:nvPr/>
        </p:nvSpPr>
        <p:spPr>
          <a:xfrm rot="18003512">
            <a:off x="1898613" y="1665028"/>
            <a:ext cx="14573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2749CEC-9493-460F-9BEB-0BC92ACDEA78}"/>
              </a:ext>
            </a:extLst>
          </p:cNvPr>
          <p:cNvSpPr txBox="1"/>
          <p:nvPr/>
        </p:nvSpPr>
        <p:spPr>
          <a:xfrm rot="18003512">
            <a:off x="2651587" y="1854642"/>
            <a:ext cx="9960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0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0998FFA-3F2A-46EF-80BB-1174DCA4CED4}"/>
              </a:ext>
            </a:extLst>
          </p:cNvPr>
          <p:cNvSpPr txBox="1"/>
          <p:nvPr/>
        </p:nvSpPr>
        <p:spPr>
          <a:xfrm rot="18003512">
            <a:off x="2033779" y="1309908"/>
            <a:ext cx="22316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D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081448A-7A7B-4409-970C-10B84384D026}"/>
              </a:ext>
            </a:extLst>
          </p:cNvPr>
          <p:cNvSpPr txBox="1"/>
          <p:nvPr/>
        </p:nvSpPr>
        <p:spPr>
          <a:xfrm rot="18003512">
            <a:off x="4009011" y="1888248"/>
            <a:ext cx="9833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1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AE28E60-6E91-49DD-B8EC-7425447060BB}"/>
              </a:ext>
            </a:extLst>
          </p:cNvPr>
          <p:cNvSpPr txBox="1"/>
          <p:nvPr/>
        </p:nvSpPr>
        <p:spPr>
          <a:xfrm rot="18003512">
            <a:off x="3271047" y="1779595"/>
            <a:ext cx="11463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2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995EBBC-5A21-48A0-AA05-11C9C50A8455}"/>
              </a:ext>
            </a:extLst>
          </p:cNvPr>
          <p:cNvSpPr txBox="1"/>
          <p:nvPr/>
        </p:nvSpPr>
        <p:spPr>
          <a:xfrm rot="18003512">
            <a:off x="3630355" y="1808532"/>
            <a:ext cx="10794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23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2E38F88-E580-41E8-A5A3-7F90835D9EF0}"/>
              </a:ext>
            </a:extLst>
          </p:cNvPr>
          <p:cNvSpPr txBox="1"/>
          <p:nvPr/>
        </p:nvSpPr>
        <p:spPr>
          <a:xfrm rot="18003512">
            <a:off x="2988309" y="1866566"/>
            <a:ext cx="9684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4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1242DE8-5807-498F-9269-6F3D7706CF66}"/>
              </a:ext>
            </a:extLst>
          </p:cNvPr>
          <p:cNvSpPr txBox="1"/>
          <p:nvPr/>
        </p:nvSpPr>
        <p:spPr>
          <a:xfrm rot="18003512">
            <a:off x="7477307" y="1828170"/>
            <a:ext cx="10989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6D80060-961B-42B4-B554-31BF33F7E75F}"/>
              </a:ext>
            </a:extLst>
          </p:cNvPr>
          <p:cNvSpPr txBox="1"/>
          <p:nvPr/>
        </p:nvSpPr>
        <p:spPr>
          <a:xfrm rot="18003512">
            <a:off x="7702767" y="1693116"/>
            <a:ext cx="14573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0E4BAF0-C456-4FD0-8E85-C9AB99E69AD5}"/>
              </a:ext>
            </a:extLst>
          </p:cNvPr>
          <p:cNvSpPr txBox="1"/>
          <p:nvPr/>
        </p:nvSpPr>
        <p:spPr>
          <a:xfrm rot="18003512">
            <a:off x="8455741" y="1882730"/>
            <a:ext cx="9960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0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2AB40F1-9008-44C7-8843-CD368DDE23D6}"/>
              </a:ext>
            </a:extLst>
          </p:cNvPr>
          <p:cNvSpPr txBox="1"/>
          <p:nvPr/>
        </p:nvSpPr>
        <p:spPr>
          <a:xfrm rot="18003512">
            <a:off x="7837933" y="1337996"/>
            <a:ext cx="22316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D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6795862-6F91-4B32-848D-AE76C31347CD}"/>
              </a:ext>
            </a:extLst>
          </p:cNvPr>
          <p:cNvSpPr txBox="1"/>
          <p:nvPr/>
        </p:nvSpPr>
        <p:spPr>
          <a:xfrm rot="18003512">
            <a:off x="9805392" y="1888247"/>
            <a:ext cx="9833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1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8370086-0E25-4919-B841-CCDAD01D4C52}"/>
              </a:ext>
            </a:extLst>
          </p:cNvPr>
          <p:cNvSpPr txBox="1"/>
          <p:nvPr/>
        </p:nvSpPr>
        <p:spPr>
          <a:xfrm rot="18003512">
            <a:off x="9075201" y="1807683"/>
            <a:ext cx="11463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2E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22E0C49-1B57-41FF-8D55-2C79BEBAE291}"/>
              </a:ext>
            </a:extLst>
          </p:cNvPr>
          <p:cNvSpPr txBox="1"/>
          <p:nvPr/>
        </p:nvSpPr>
        <p:spPr>
          <a:xfrm rot="18003512">
            <a:off x="9434509" y="1836620"/>
            <a:ext cx="10794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23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E41573A-33D6-4846-AA6B-DF24FCA12087}"/>
              </a:ext>
            </a:extLst>
          </p:cNvPr>
          <p:cNvSpPr txBox="1"/>
          <p:nvPr/>
        </p:nvSpPr>
        <p:spPr>
          <a:xfrm rot="18003512">
            <a:off x="8799051" y="1866566"/>
            <a:ext cx="9684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4E</a:t>
            </a:r>
          </a:p>
        </p:txBody>
      </p:sp>
    </p:spTree>
    <p:extLst>
      <p:ext uri="{BB962C8B-B14F-4D97-AF65-F5344CB8AC3E}">
        <p14:creationId xmlns:p14="http://schemas.microsoft.com/office/powerpoint/2010/main" val="29984859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close up of a computer&#10;&#10;Description automatically generated">
            <a:extLst>
              <a:ext uri="{FF2B5EF4-FFF2-40B4-BE49-F238E27FC236}">
                <a16:creationId xmlns:a16="http://schemas.microsoft.com/office/drawing/2014/main" id="{D185095B-6394-420D-A91C-D49F2D855AF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86562" y="2599461"/>
            <a:ext cx="4276726" cy="3805343"/>
          </a:xfrm>
          <a:prstGeom prst="rect">
            <a:avLst/>
          </a:prstGeom>
        </p:spPr>
      </p:pic>
      <p:pic>
        <p:nvPicPr>
          <p:cNvPr id="5" name="Picture 4" descr="A screenshot of a computer&#10;&#10;Description automatically generated">
            <a:extLst>
              <a:ext uri="{FF2B5EF4-FFF2-40B4-BE49-F238E27FC236}">
                <a16:creationId xmlns:a16="http://schemas.microsoft.com/office/drawing/2014/main" id="{9493FBF8-ACA6-4C95-BF60-F36BBEA25BB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7614" y="2599461"/>
            <a:ext cx="4276726" cy="380534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9955679-0163-4F46-90D1-D758762E9AB9}"/>
              </a:ext>
            </a:extLst>
          </p:cNvPr>
          <p:cNvSpPr txBox="1"/>
          <p:nvPr/>
        </p:nvSpPr>
        <p:spPr>
          <a:xfrm>
            <a:off x="2552700" y="59293"/>
            <a:ext cx="1226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0919449-326D-421D-B10B-17495C92A4B5}"/>
              </a:ext>
            </a:extLst>
          </p:cNvPr>
          <p:cNvSpPr txBox="1"/>
          <p:nvPr/>
        </p:nvSpPr>
        <p:spPr>
          <a:xfrm>
            <a:off x="8117653" y="59293"/>
            <a:ext cx="1614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ified </a:t>
            </a:r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3EB329D-44AD-4FAF-9B62-222FD8B3CE78}"/>
              </a:ext>
            </a:extLst>
          </p:cNvPr>
          <p:cNvSpPr txBox="1"/>
          <p:nvPr/>
        </p:nvSpPr>
        <p:spPr>
          <a:xfrm rot="18003512">
            <a:off x="1388693" y="1935455"/>
            <a:ext cx="10989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469D5B7-2D11-4F6E-B442-7BFED549E378}"/>
              </a:ext>
            </a:extLst>
          </p:cNvPr>
          <p:cNvSpPr txBox="1"/>
          <p:nvPr/>
        </p:nvSpPr>
        <p:spPr>
          <a:xfrm rot="18003512">
            <a:off x="1624080" y="1790391"/>
            <a:ext cx="14573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2F94FC6-DD17-48B7-B7F6-B35A598C6005}"/>
              </a:ext>
            </a:extLst>
          </p:cNvPr>
          <p:cNvSpPr txBox="1"/>
          <p:nvPr/>
        </p:nvSpPr>
        <p:spPr>
          <a:xfrm rot="18003512">
            <a:off x="2453052" y="1990015"/>
            <a:ext cx="9960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0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B225F3F-C3BD-4613-9D5E-E30B990330C5}"/>
              </a:ext>
            </a:extLst>
          </p:cNvPr>
          <p:cNvSpPr txBox="1"/>
          <p:nvPr/>
        </p:nvSpPr>
        <p:spPr>
          <a:xfrm rot="18003512">
            <a:off x="1746542" y="1445280"/>
            <a:ext cx="22316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D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2B572D2-A177-41B6-A895-E21FEE7F2840}"/>
              </a:ext>
            </a:extLst>
          </p:cNvPr>
          <p:cNvSpPr txBox="1"/>
          <p:nvPr/>
        </p:nvSpPr>
        <p:spPr>
          <a:xfrm rot="18003512">
            <a:off x="2808330" y="1985521"/>
            <a:ext cx="9833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1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29A5AB7-B15B-47A4-BBFA-93FE2805DEA0}"/>
              </a:ext>
            </a:extLst>
          </p:cNvPr>
          <p:cNvSpPr txBox="1"/>
          <p:nvPr/>
        </p:nvSpPr>
        <p:spPr>
          <a:xfrm rot="18003512">
            <a:off x="3121062" y="1914967"/>
            <a:ext cx="11463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2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9FC5033-4C29-4DBC-92BD-6E0A2C7BE1CF}"/>
              </a:ext>
            </a:extLst>
          </p:cNvPr>
          <p:cNvSpPr txBox="1"/>
          <p:nvPr/>
        </p:nvSpPr>
        <p:spPr>
          <a:xfrm rot="18003512">
            <a:off x="3489437" y="1943904"/>
            <a:ext cx="10794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23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C93A4F8-8AF2-45E6-8488-1D9ABFF00774}"/>
              </a:ext>
            </a:extLst>
          </p:cNvPr>
          <p:cNvSpPr txBox="1"/>
          <p:nvPr/>
        </p:nvSpPr>
        <p:spPr>
          <a:xfrm rot="18003512">
            <a:off x="3921846" y="2011948"/>
            <a:ext cx="9684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4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474D528-80D8-45CC-B85A-EAD0ABD432C9}"/>
              </a:ext>
            </a:extLst>
          </p:cNvPr>
          <p:cNvSpPr txBox="1"/>
          <p:nvPr/>
        </p:nvSpPr>
        <p:spPr>
          <a:xfrm rot="18003512">
            <a:off x="7103862" y="1935455"/>
            <a:ext cx="10989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741773D-2C2D-4BA3-AA01-E4A050439998}"/>
              </a:ext>
            </a:extLst>
          </p:cNvPr>
          <p:cNvSpPr txBox="1"/>
          <p:nvPr/>
        </p:nvSpPr>
        <p:spPr>
          <a:xfrm rot="18003512">
            <a:off x="7339249" y="1790391"/>
            <a:ext cx="14573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F932704-EC8B-4EB6-9997-F8D159E19765}"/>
              </a:ext>
            </a:extLst>
          </p:cNvPr>
          <p:cNvSpPr txBox="1"/>
          <p:nvPr/>
        </p:nvSpPr>
        <p:spPr>
          <a:xfrm rot="18003512">
            <a:off x="8168221" y="1990015"/>
            <a:ext cx="9960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0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9E98198-66E6-40ED-B331-8BA14609237D}"/>
              </a:ext>
            </a:extLst>
          </p:cNvPr>
          <p:cNvSpPr txBox="1"/>
          <p:nvPr/>
        </p:nvSpPr>
        <p:spPr>
          <a:xfrm rot="18003512">
            <a:off x="7461711" y="1445280"/>
            <a:ext cx="22316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D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CD4BE95-B3DC-4CA9-BBD5-AD7350192295}"/>
              </a:ext>
            </a:extLst>
          </p:cNvPr>
          <p:cNvSpPr txBox="1"/>
          <p:nvPr/>
        </p:nvSpPr>
        <p:spPr>
          <a:xfrm rot="18003512">
            <a:off x="8523499" y="1985521"/>
            <a:ext cx="9833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1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29294CB-3BBF-40EA-BF68-B79E894A08C3}"/>
              </a:ext>
            </a:extLst>
          </p:cNvPr>
          <p:cNvSpPr txBox="1"/>
          <p:nvPr/>
        </p:nvSpPr>
        <p:spPr>
          <a:xfrm rot="18003512">
            <a:off x="8836231" y="1914967"/>
            <a:ext cx="11463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2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EF1CCD5-BF31-42B3-98C0-B4DD44B2D523}"/>
              </a:ext>
            </a:extLst>
          </p:cNvPr>
          <p:cNvSpPr txBox="1"/>
          <p:nvPr/>
        </p:nvSpPr>
        <p:spPr>
          <a:xfrm rot="18003512">
            <a:off x="9204606" y="1943904"/>
            <a:ext cx="10794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23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7B9BE33-7686-427C-BD22-88E21C71461D}"/>
              </a:ext>
            </a:extLst>
          </p:cNvPr>
          <p:cNvSpPr txBox="1"/>
          <p:nvPr/>
        </p:nvSpPr>
        <p:spPr>
          <a:xfrm rot="18003512">
            <a:off x="9637015" y="2011948"/>
            <a:ext cx="9684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4E</a:t>
            </a:r>
          </a:p>
        </p:txBody>
      </p:sp>
    </p:spTree>
    <p:extLst>
      <p:ext uri="{BB962C8B-B14F-4D97-AF65-F5344CB8AC3E}">
        <p14:creationId xmlns:p14="http://schemas.microsoft.com/office/powerpoint/2010/main" val="28709956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Text&#10;&#10;Description automatically generated">
            <a:extLst>
              <a:ext uri="{FF2B5EF4-FFF2-40B4-BE49-F238E27FC236}">
                <a16:creationId xmlns:a16="http://schemas.microsoft.com/office/drawing/2014/main" id="{29627C7F-51F5-4776-AB09-DAA36D9E62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58336" y="2309955"/>
            <a:ext cx="4533181" cy="4119420"/>
          </a:xfrm>
          <a:prstGeom prst="rect">
            <a:avLst/>
          </a:prstGeom>
        </p:spPr>
      </p:pic>
      <p:pic>
        <p:nvPicPr>
          <p:cNvPr id="3" name="Picture 2" descr="Graphical user interface, text, application&#10;&#10;Description automatically generated">
            <a:extLst>
              <a:ext uri="{FF2B5EF4-FFF2-40B4-BE49-F238E27FC236}">
                <a16:creationId xmlns:a16="http://schemas.microsoft.com/office/drawing/2014/main" id="{E651B7AD-5EF9-42A3-86CC-4A00343223A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0009" y="2309955"/>
            <a:ext cx="4533181" cy="411942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CE9718E-2ACD-446D-B733-1858D2FED2C9}"/>
              </a:ext>
            </a:extLst>
          </p:cNvPr>
          <p:cNvSpPr txBox="1"/>
          <p:nvPr/>
        </p:nvSpPr>
        <p:spPr>
          <a:xfrm>
            <a:off x="2552700" y="59293"/>
            <a:ext cx="1226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73AE775-41E7-4F96-9587-478FC531C508}"/>
              </a:ext>
            </a:extLst>
          </p:cNvPr>
          <p:cNvSpPr txBox="1"/>
          <p:nvPr/>
        </p:nvSpPr>
        <p:spPr>
          <a:xfrm>
            <a:off x="8117653" y="59293"/>
            <a:ext cx="1614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ified </a:t>
            </a:r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1695064-F06C-4BDF-9389-552516D64285}"/>
              </a:ext>
            </a:extLst>
          </p:cNvPr>
          <p:cNvSpPr txBox="1"/>
          <p:nvPr/>
        </p:nvSpPr>
        <p:spPr>
          <a:xfrm rot="18003512">
            <a:off x="7615473" y="1415210"/>
            <a:ext cx="14573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14DC56A-4FFF-4EA5-9681-A3FA32EFAF95}"/>
              </a:ext>
            </a:extLst>
          </p:cNvPr>
          <p:cNvSpPr txBox="1"/>
          <p:nvPr/>
        </p:nvSpPr>
        <p:spPr>
          <a:xfrm rot="18003512">
            <a:off x="7380086" y="1560274"/>
            <a:ext cx="10989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8F88AE4-EB6E-4C29-9A9D-B624ECADA502}"/>
              </a:ext>
            </a:extLst>
          </p:cNvPr>
          <p:cNvSpPr txBox="1"/>
          <p:nvPr/>
        </p:nvSpPr>
        <p:spPr>
          <a:xfrm rot="18003512">
            <a:off x="7615473" y="1415210"/>
            <a:ext cx="14573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C651192-72B0-427A-A5A8-561FE173004A}"/>
              </a:ext>
            </a:extLst>
          </p:cNvPr>
          <p:cNvSpPr txBox="1"/>
          <p:nvPr/>
        </p:nvSpPr>
        <p:spPr>
          <a:xfrm rot="18003512">
            <a:off x="8444445" y="1614834"/>
            <a:ext cx="9960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0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7CBA6E5-8A9F-4690-BB93-01B8273DB60E}"/>
              </a:ext>
            </a:extLst>
          </p:cNvPr>
          <p:cNvSpPr txBox="1"/>
          <p:nvPr/>
        </p:nvSpPr>
        <p:spPr>
          <a:xfrm rot="18003512">
            <a:off x="7737935" y="1070099"/>
            <a:ext cx="22316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D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A7B1C98-FC09-4257-A79B-B2971A63E20A}"/>
              </a:ext>
            </a:extLst>
          </p:cNvPr>
          <p:cNvSpPr txBox="1"/>
          <p:nvPr/>
        </p:nvSpPr>
        <p:spPr>
          <a:xfrm rot="18003512">
            <a:off x="8799723" y="1610340"/>
            <a:ext cx="9833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1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EBBBFEA-6C85-43E7-8A17-A2AE86171559}"/>
              </a:ext>
            </a:extLst>
          </p:cNvPr>
          <p:cNvSpPr txBox="1"/>
          <p:nvPr/>
        </p:nvSpPr>
        <p:spPr>
          <a:xfrm rot="18003512">
            <a:off x="9112455" y="1539786"/>
            <a:ext cx="11463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2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19C701F-2A27-4F0F-930C-9DECC6221060}"/>
              </a:ext>
            </a:extLst>
          </p:cNvPr>
          <p:cNvSpPr txBox="1"/>
          <p:nvPr/>
        </p:nvSpPr>
        <p:spPr>
          <a:xfrm rot="18003512">
            <a:off x="9480830" y="1568723"/>
            <a:ext cx="10794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23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5FE159A-8C3E-4255-8D92-BBC24EA403E1}"/>
              </a:ext>
            </a:extLst>
          </p:cNvPr>
          <p:cNvSpPr txBox="1"/>
          <p:nvPr/>
        </p:nvSpPr>
        <p:spPr>
          <a:xfrm rot="18003512">
            <a:off x="9913239" y="1636767"/>
            <a:ext cx="9684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4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840D10C-44AB-442D-BF3C-0B04ABB09913}"/>
              </a:ext>
            </a:extLst>
          </p:cNvPr>
          <p:cNvSpPr txBox="1"/>
          <p:nvPr/>
        </p:nvSpPr>
        <p:spPr>
          <a:xfrm rot="18003512">
            <a:off x="2012347" y="1457246"/>
            <a:ext cx="14573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AF2925C-892F-410F-B401-864B83B614E6}"/>
              </a:ext>
            </a:extLst>
          </p:cNvPr>
          <p:cNvSpPr txBox="1"/>
          <p:nvPr/>
        </p:nvSpPr>
        <p:spPr>
          <a:xfrm rot="18003512">
            <a:off x="1776960" y="1602310"/>
            <a:ext cx="10989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8D7DD33-A22A-49CE-805C-0B0A068004C3}"/>
              </a:ext>
            </a:extLst>
          </p:cNvPr>
          <p:cNvSpPr txBox="1"/>
          <p:nvPr/>
        </p:nvSpPr>
        <p:spPr>
          <a:xfrm rot="18003512">
            <a:off x="2012347" y="1457246"/>
            <a:ext cx="14573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600B978-5A5D-4140-A7F5-06FC5DAABA56}"/>
              </a:ext>
            </a:extLst>
          </p:cNvPr>
          <p:cNvSpPr txBox="1"/>
          <p:nvPr/>
        </p:nvSpPr>
        <p:spPr>
          <a:xfrm rot="18003512">
            <a:off x="2841319" y="1656870"/>
            <a:ext cx="9960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0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6EC12B9-75B0-42CA-833C-7EF7F257FD19}"/>
              </a:ext>
            </a:extLst>
          </p:cNvPr>
          <p:cNvSpPr txBox="1"/>
          <p:nvPr/>
        </p:nvSpPr>
        <p:spPr>
          <a:xfrm rot="18003512">
            <a:off x="2134809" y="1112135"/>
            <a:ext cx="22316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D</a:t>
            </a:r>
            <a:r>
              <a:rPr lang="en-AU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AU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xE</a:t>
            </a:r>
            <a:endParaRPr lang="en-A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09D5796-6268-4D56-842F-3D053E9BD6C0}"/>
              </a:ext>
            </a:extLst>
          </p:cNvPr>
          <p:cNvSpPr txBox="1"/>
          <p:nvPr/>
        </p:nvSpPr>
        <p:spPr>
          <a:xfrm rot="18003512">
            <a:off x="3196597" y="1652376"/>
            <a:ext cx="9833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1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A5DCAEF-7803-4BC2-AE99-5C7E1AD21D6B}"/>
              </a:ext>
            </a:extLst>
          </p:cNvPr>
          <p:cNvSpPr txBox="1"/>
          <p:nvPr/>
        </p:nvSpPr>
        <p:spPr>
          <a:xfrm rot="18003512">
            <a:off x="3509329" y="1581822"/>
            <a:ext cx="11463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2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73A1DFD-B355-4875-A81A-C465F6FE37FC}"/>
              </a:ext>
            </a:extLst>
          </p:cNvPr>
          <p:cNvSpPr txBox="1"/>
          <p:nvPr/>
        </p:nvSpPr>
        <p:spPr>
          <a:xfrm rot="18003512">
            <a:off x="3877704" y="1610759"/>
            <a:ext cx="10794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23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A45A89B-35AB-4FA7-975E-24DC0548D817}"/>
              </a:ext>
            </a:extLst>
          </p:cNvPr>
          <p:cNvSpPr txBox="1"/>
          <p:nvPr/>
        </p:nvSpPr>
        <p:spPr>
          <a:xfrm rot="18003512">
            <a:off x="4310113" y="1678803"/>
            <a:ext cx="9684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4E</a:t>
            </a:r>
          </a:p>
        </p:txBody>
      </p:sp>
    </p:spTree>
    <p:extLst>
      <p:ext uri="{BB962C8B-B14F-4D97-AF65-F5344CB8AC3E}">
        <p14:creationId xmlns:p14="http://schemas.microsoft.com/office/powerpoint/2010/main" val="35862618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94</Words>
  <Application>Microsoft Office PowerPoint</Application>
  <PresentationFormat>Widescreen</PresentationFormat>
  <Paragraphs>5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 Icke</dc:creator>
  <cp:lastModifiedBy>Chris Icke</cp:lastModifiedBy>
  <cp:revision>1</cp:revision>
  <dcterms:created xsi:type="dcterms:W3CDTF">2020-12-04T04:35:21Z</dcterms:created>
  <dcterms:modified xsi:type="dcterms:W3CDTF">2020-12-04T04:43:17Z</dcterms:modified>
</cp:coreProperties>
</file>